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 showGuides="1">
      <p:cViewPr varScale="1">
        <p:scale>
          <a:sx n="67" d="100"/>
          <a:sy n="67" d="100"/>
        </p:scale>
        <p:origin x="1668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3765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2887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3501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2976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2165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5290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3072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5755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0480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2138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0332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CEFE9-666A-4460-8431-F828D92A4519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3AF6B3-6EDA-4B19-ACFC-FBE7B1235D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3628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5496" y="116632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Fig. 3</a:t>
            </a:r>
            <a:endParaRPr lang="de-DE" dirty="0"/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8647" y="142972"/>
            <a:ext cx="3606706" cy="3943235"/>
          </a:xfrm>
          <a:prstGeom prst="rect">
            <a:avLst/>
          </a:prstGeom>
        </p:spPr>
      </p:pic>
      <p:sp>
        <p:nvSpPr>
          <p:cNvPr id="17" name="Rechteck 16"/>
          <p:cNvSpPr/>
          <p:nvPr/>
        </p:nvSpPr>
        <p:spPr>
          <a:xfrm>
            <a:off x="251520" y="4219778"/>
            <a:ext cx="8712968" cy="23775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ribution 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CCAAT-boxes to promoter activity.</a:t>
            </a:r>
            <a:endParaRPr lang="de-DE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uciferase reporter promoter assays from transfected NIH3T3 and RPE-1 cells that were serum-starved and restimulated by serum addition to the media. Transfected plasmids were the empty reporter vector pGL4.10 (vector control) and wild-type or mutant reporter plasmid constructs based on the 596 bp </a:t>
            </a:r>
            <a:r>
              <a:rPr lang="en-US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KI67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moter fragment (see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Suppl. Fig.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): wild-type (wt) and single as well as combinations of CCAAT-box mutations: CCAAT1, CCAAT2, CCAAT3, CCAAT2/3 or CCAAT1/2/3. Relative light units (RLU) were calculated as the ratio of firefly luciferase activity from the promoter reporter constructs to the </a:t>
            </a:r>
            <a:r>
              <a:rPr lang="en-US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nilla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uciferase activity from a cotransfected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rol plasmid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acking a promoter. NIH3T3 cells and hTERT-RPE-1 cells (RPE-1) were serum-starved for 72 h (0 h, grey) and restimulated by serum addition for 24 h (NIH3T3) or 29 h (RPE-1) (blue). Cells were collected and RLUs measured in technical duplicates. One representative experiment out of two biological replicates is shown. The relative fold–change in RLUs from 0 h to 24 h/ 29 h for each promoter construct was calculated and is given above the columns. For all graphs mean values ±SD are given.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34007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8</Words>
  <Application>Microsoft Office PowerPoint</Application>
  <PresentationFormat>Bildschirmpräsentation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üller, Gerd</dc:creator>
  <cp:lastModifiedBy>Engeland, Kurt</cp:lastModifiedBy>
  <cp:revision>11</cp:revision>
  <dcterms:created xsi:type="dcterms:W3CDTF">2020-05-28T17:53:42Z</dcterms:created>
  <dcterms:modified xsi:type="dcterms:W3CDTF">2021-06-13T06:30:43Z</dcterms:modified>
</cp:coreProperties>
</file>